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544" y="-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720" cy="4572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26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09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09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452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36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76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222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9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348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07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875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6D29A-5721-4A07-A0B5-2C411A5F3E66}" type="datetimeFigureOut">
              <a:rPr lang="en-US" smtClean="0"/>
              <a:t>4/23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6AC78-38C6-4304-B982-36D213BF2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726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animalgenome.org/cgi-bin/QTLdb/BT/qdetails?QTL_ID=11536" TargetMode="External"/><Relationship Id="rId4" Type="http://schemas.openxmlformats.org/officeDocument/2006/relationships/hyperlink" Target="http://www.animalgenome.org/cgi-bin/QTLdb/SS/ontrait?trait_ID=720" TargetMode="External"/><Relationship Id="rId5" Type="http://schemas.openxmlformats.org/officeDocument/2006/relationships/hyperlink" Target="http://www.animalgenome.org/cgi-bin/QTLdb/GG/traitmap?trait_ID=2101" TargetMode="External"/><Relationship Id="rId6" Type="http://schemas.openxmlformats.org/officeDocument/2006/relationships/hyperlink" Target="http://rgd.mcw.edu/rgdweb/ontology/annot.html?acc_id=VT:0000188" TargetMode="External"/><Relationship Id="rId7" Type="http://schemas.openxmlformats.org/officeDocument/2006/relationships/hyperlink" Target="http://phenome.jax.org/db/q?rtn=meas/catlister&amp;req=OVT:0000188" TargetMode="External"/><Relationship Id="rId8" Type="http://schemas.openxmlformats.org/officeDocument/2006/relationships/hyperlink" Target="http://rgd.mcw.edu/phenotypes/" TargetMode="Externa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" y="0"/>
            <a:ext cx="19202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ockup of a putative cross-species "trait portal"</a:t>
            </a:r>
            <a:endParaRPr lang="en-US" sz="14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11147" y="85189"/>
            <a:ext cx="4121706" cy="646331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b="1" u="sng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rait:</a:t>
            </a:r>
            <a:endParaRPr lang="en-US" dirty="0" smtClean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lood </a:t>
            </a:r>
            <a:r>
              <a:rPr lang="en-US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glucose </a:t>
            </a:r>
            <a:r>
              <a:rPr lang="en-US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mount</a:t>
            </a:r>
            <a:r>
              <a:rPr lang="en-US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(VT:0000188)</a:t>
            </a:r>
            <a:endParaRPr lang="en-US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583680" y="671211"/>
            <a:ext cx="23519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xplore the ontology:</a:t>
            </a:r>
            <a:endParaRPr lang="en-US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6675120" y="1005840"/>
            <a:ext cx="1645920" cy="2194560"/>
            <a:chOff x="6812280" y="640080"/>
            <a:chExt cx="1737360" cy="2514600"/>
          </a:xfrm>
        </p:grpSpPr>
        <p:sp>
          <p:nvSpPr>
            <p:cNvPr id="8" name="Rounded Rectangle 7"/>
            <p:cNvSpPr/>
            <p:nvPr/>
          </p:nvSpPr>
          <p:spPr>
            <a:xfrm>
              <a:off x="6812280" y="640080"/>
              <a:ext cx="1737360" cy="2514600"/>
            </a:xfrm>
            <a:prstGeom prst="roundRect">
              <a:avLst/>
            </a:prstGeom>
            <a:solidFill>
              <a:schemeClr val="accent3">
                <a:lumMod val="20000"/>
                <a:lumOff val="8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59419" y="761142"/>
              <a:ext cx="1243083" cy="22724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1" name="Rounded Rectangle 10"/>
          <p:cNvSpPr/>
          <p:nvPr/>
        </p:nvSpPr>
        <p:spPr>
          <a:xfrm>
            <a:off x="320040" y="1280159"/>
            <a:ext cx="2544346" cy="1859647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 anchorCtr="0"/>
          <a:lstStyle/>
          <a:p>
            <a:endParaRPr lang="en-US" sz="1600" dirty="0">
              <a:solidFill>
                <a:schemeClr val="accent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42085" y="1314366"/>
            <a:ext cx="2100256" cy="119417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pPr lvl="0">
              <a:spcBef>
                <a:spcPct val="20000"/>
              </a:spcBef>
            </a:pPr>
            <a:r>
              <a:rPr lang="en-US" sz="1400" u="sng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QTL data:</a:t>
            </a:r>
          </a:p>
          <a:p>
            <a:pPr marL="342900" lvl="0" indent="-342900">
              <a:spcBef>
                <a:spcPct val="20000"/>
              </a:spcBef>
              <a:buFont typeface="Wingdings" pitchFamily="2" charset="2"/>
              <a:buChar char="q"/>
            </a:pP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3"/>
              </a:rPr>
              <a:t>CattleQTLdb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342900" lvl="0" indent="-342900">
              <a:spcBef>
                <a:spcPct val="20000"/>
              </a:spcBef>
              <a:buFont typeface="Wingdings" pitchFamily="2" charset="2"/>
              <a:buChar char="q"/>
            </a:pP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4"/>
              </a:rPr>
              <a:t>PigQTLdb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342900" lvl="0" indent="-342900">
              <a:spcBef>
                <a:spcPct val="20000"/>
              </a:spcBef>
              <a:buFont typeface="Wingdings" pitchFamily="2" charset="2"/>
              <a:buChar char="q"/>
            </a:pP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5"/>
              </a:rPr>
              <a:t>ChickenQTLdb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342900" lvl="0" indent="-342900">
              <a:spcBef>
                <a:spcPct val="20000"/>
              </a:spcBef>
              <a:buFont typeface="Wingdings" pitchFamily="2" charset="2"/>
              <a:buChar char="q"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6"/>
              </a:rPr>
              <a:t>Rat Genome </a:t>
            </a:r>
            <a:r>
              <a:rPr lang="en-US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6"/>
              </a:rPr>
              <a:t>Database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320577" y="1280159"/>
            <a:ext cx="2543877" cy="749141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 w="25400">
            <a:solidFill>
              <a:schemeClr val="accent3">
                <a:lumMod val="75000"/>
              </a:schemeClr>
            </a:solidFill>
          </a:ln>
        </p:spPr>
        <p:txBody>
          <a:bodyPr wrap="none" rtlCol="0">
            <a:spAutoFit/>
          </a:bodyPr>
          <a:lstStyle/>
          <a:p>
            <a:pPr lvl="0"/>
            <a:r>
              <a:rPr lang="en-US" sz="1400" u="sng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Quantitative phenotype data:</a:t>
            </a:r>
          </a:p>
          <a:p>
            <a:pPr marL="285750" lvl="0" indent="-285750">
              <a:buFont typeface="Arial" pitchFamily="34" charset="0"/>
              <a:buChar char="•"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7"/>
              </a:rPr>
              <a:t>Mouse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7"/>
              </a:rPr>
              <a:t>Phenome</a:t>
            </a: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7"/>
              </a:rPr>
              <a:t> Database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  <a:p>
            <a:pPr marL="285750" lvl="0" indent="-285750">
              <a:buFont typeface="Arial" pitchFamily="34" charset="0"/>
              <a:buChar char="•"/>
            </a:pPr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8"/>
              </a:rPr>
              <a:t>Rat </a:t>
            </a:r>
            <a:r>
              <a:rPr lang="en-US" sz="1200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  <a:hlinkClick r:id="rId8"/>
              </a:rPr>
              <a:t>PhenoMiner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" name="Group 18"/>
          <p:cNvGrpSpPr/>
          <p:nvPr/>
        </p:nvGrpSpPr>
        <p:grpSpPr>
          <a:xfrm>
            <a:off x="320039" y="3520440"/>
            <a:ext cx="8248227" cy="3154680"/>
            <a:chOff x="320040" y="3520440"/>
            <a:chExt cx="7788374" cy="3154680"/>
          </a:xfrm>
        </p:grpSpPr>
        <p:sp>
          <p:nvSpPr>
            <p:cNvPr id="16" name="Rounded Rectangle 15"/>
            <p:cNvSpPr/>
            <p:nvPr/>
          </p:nvSpPr>
          <p:spPr>
            <a:xfrm>
              <a:off x="320040" y="3520440"/>
              <a:ext cx="7788374" cy="315468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 anchorCtr="0"/>
            <a:lstStyle/>
            <a:p>
              <a:r>
                <a:rPr lang="en-US" sz="1400" u="sng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hoose one or more terms:</a:t>
              </a:r>
            </a:p>
            <a:p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ammalian Phenotype: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bnormal glucose </a:t>
              </a: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bsorption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Increased circulating </a:t>
              </a: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se </a:t>
              </a: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level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Decreased </a:t>
              </a: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irculating glucose level</a:t>
              </a:r>
            </a:p>
            <a:p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Disease: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Diabetes </a:t>
              </a: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llitus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se/</a:t>
              </a:r>
              <a:r>
                <a:rPr lang="en-US" sz="1000" dirty="0" err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alactose</a:t>
              </a: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000" dirty="0" err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alabsorption</a:t>
              </a:r>
              <a:endPara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olecular Pathway: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se homeostasis </a:t>
              </a: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athway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insulin signaling pathway</a:t>
              </a:r>
              <a:endPara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logical Process: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neogenesis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egulation of glucose transport</a:t>
              </a:r>
              <a:endPara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12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olecular Function: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se </a:t>
              </a: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nding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se </a:t>
              </a:r>
              <a:r>
                <a:rPr lang="en-US" sz="1000" dirty="0" err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ransmembrane</a:t>
              </a: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transporter activity</a:t>
              </a:r>
              <a:endPara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600" dirty="0">
                <a:solidFill>
                  <a:schemeClr val="accent5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3859210" y="3760892"/>
              <a:ext cx="3246120" cy="2402840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numCol="2" spcCol="91440" rtlCol="0" anchor="t" anchorCtr="0"/>
            <a:lstStyle/>
            <a:p>
              <a:r>
                <a:rPr lang="en-US" sz="12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enes: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Human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ouse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at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attle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ig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hicken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heep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Zebrafish</a:t>
              </a:r>
              <a:endPara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Drosophila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Nematode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Yeast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rabidopsis</a:t>
              </a:r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12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QTL: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Human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at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ouse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attle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ig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hicken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heep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endParaRPr lang="en-US" sz="10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en-US" sz="12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trains:</a:t>
              </a:r>
              <a:endParaRPr lang="en-US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Rat</a:t>
              </a:r>
            </a:p>
            <a:p>
              <a:pPr marL="171450" indent="-171450">
                <a:buFont typeface="Wingdings" pitchFamily="2" charset="2"/>
                <a:buChar char="q"/>
              </a:pPr>
              <a:r>
                <a:rPr lang="en-US" sz="10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ouse</a:t>
              </a:r>
            </a:p>
            <a:p>
              <a:pPr marL="171450" lvl="0" indent="-171450">
                <a:buFont typeface="Wingdings" pitchFamily="2" charset="2"/>
                <a:buChar char="q"/>
              </a:pPr>
              <a:endParaRPr lang="en-US" sz="1000" dirty="0" smtClean="0">
                <a:solidFill>
                  <a:schemeClr val="accent5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  <a:p>
              <a:pPr algn="ctr"/>
              <a:endParaRPr lang="en-US" sz="1600" dirty="0">
                <a:solidFill>
                  <a:schemeClr val="accent5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13490" y="3611693"/>
              <a:ext cx="32181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lang="en-US" sz="1400" u="sng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oose one or more </a:t>
              </a:r>
              <a:r>
                <a:rPr lang="en-US" sz="1400" u="sng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data types/species:</a:t>
              </a:r>
              <a:r>
                <a:rPr lang="en-US" dirty="0" smtClean="0"/>
                <a:t> </a:t>
              </a:r>
              <a:endParaRPr lang="en-US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228600" y="945531"/>
            <a:ext cx="5211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Explore data annotated to blood glucose amount: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28600" y="3196828"/>
            <a:ext cx="3749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Explore related concepts and data: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313600" y="5460999"/>
            <a:ext cx="6708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tx2">
                    <a:lumMod val="75000"/>
                  </a:schemeClr>
                </a:solidFill>
              </a:rPr>
              <a:t>(Select all)</a:t>
            </a:r>
            <a:endParaRPr lang="en-US" sz="900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141472" y="3898051"/>
            <a:ext cx="67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tx2">
                    <a:lumMod val="75000"/>
                  </a:schemeClr>
                </a:solidFill>
              </a:rPr>
              <a:t>(Select all)</a:t>
            </a:r>
            <a:endParaRPr lang="en-US" sz="900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750407" y="3898052"/>
            <a:ext cx="6719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solidFill>
                  <a:schemeClr val="tx2">
                    <a:lumMod val="75000"/>
                  </a:schemeClr>
                </a:solidFill>
              </a:rPr>
              <a:t>(Select all)</a:t>
            </a:r>
            <a:endParaRPr lang="en-US" sz="900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28" name="Rounded Rectangle 27"/>
          <p:cNvSpPr/>
          <p:nvPr/>
        </p:nvSpPr>
        <p:spPr>
          <a:xfrm>
            <a:off x="3624551" y="6266865"/>
            <a:ext cx="2016087" cy="275422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  <a:scene3d>
            <a:camera prst="orthographicFront"/>
            <a:lightRig rig="threePt" dir="t"/>
          </a:scene3d>
          <a:sp3d>
            <a:bevelT w="165100" prst="coolSlan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 Narrow" pitchFamily="34" charset="0"/>
              </a:rPr>
              <a:t>View data annotated to ANY</a:t>
            </a:r>
            <a:endParaRPr lang="en-US" sz="1200" b="1" dirty="0">
              <a:solidFill>
                <a:schemeClr val="tx1"/>
              </a:solidFill>
              <a:latin typeface="Arial Narrow" pitchFamily="34" charset="0"/>
            </a:endParaRPr>
          </a:p>
        </p:txBody>
      </p:sp>
      <p:sp>
        <p:nvSpPr>
          <p:cNvPr id="31" name="Rounded Rectangle 30"/>
          <p:cNvSpPr/>
          <p:nvPr/>
        </p:nvSpPr>
        <p:spPr>
          <a:xfrm>
            <a:off x="5804052" y="6266865"/>
            <a:ext cx="2016087" cy="275422"/>
          </a:xfrm>
          <a:prstGeom prst="round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75000"/>
              </a:schemeClr>
            </a:solidFill>
          </a:ln>
          <a:scene3d>
            <a:camera prst="orthographicFront"/>
            <a:lightRig rig="threePt" dir="t"/>
          </a:scene3d>
          <a:sp3d>
            <a:bevelT w="165100" prst="coolSlan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 Narrow" pitchFamily="34" charset="0"/>
              </a:rPr>
              <a:t>View data annotated to ALL</a:t>
            </a:r>
            <a:endParaRPr lang="en-US" sz="1200" b="1" dirty="0">
              <a:solidFill>
                <a:schemeClr val="tx1"/>
              </a:solidFill>
              <a:latin typeface="Arial Narrow" pitchFamily="34" charset="0"/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765031" y="2588964"/>
            <a:ext cx="1654364" cy="440674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  <a:scene3d>
            <a:camera prst="orthographicFront"/>
            <a:lightRig rig="threePt" dir="t"/>
          </a:scene3d>
          <a:sp3d>
            <a:bevelT w="165100" prst="coolSlan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latin typeface="Arial Narrow" pitchFamily="34" charset="0"/>
              </a:rPr>
              <a:t>View QTL and associated annotations</a:t>
            </a:r>
            <a:endParaRPr lang="en-US" sz="1200" b="1" dirty="0">
              <a:solidFill>
                <a:schemeClr val="tx1"/>
              </a:solidFill>
              <a:latin typeface="Arial Narrow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2174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9</TotalTime>
  <Words>174</Words>
  <Application>Microsoft Macintosh PowerPoint</Application>
  <PresentationFormat>On-screen Show 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R Smith</dc:creator>
  <cp:lastModifiedBy>Cari Park</cp:lastModifiedBy>
  <cp:revision>25</cp:revision>
  <dcterms:created xsi:type="dcterms:W3CDTF">2013-04-01T18:04:37Z</dcterms:created>
  <dcterms:modified xsi:type="dcterms:W3CDTF">2013-04-23T14:34:53Z</dcterms:modified>
</cp:coreProperties>
</file>